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9" r:id="rId2"/>
  </p:sldIdLst>
  <p:sldSz cx="10287000" cy="6858000" type="35mm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44" userDrawn="1">
          <p15:clr>
            <a:srgbClr val="A4A3A4"/>
          </p15:clr>
        </p15:guide>
        <p15:guide id="2" pos="32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388F411-DFA1-4940-B970-111CE5BC50D8}" v="49" dt="2025-06-21T04:56:32.02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704" y="64"/>
      </p:cViewPr>
      <p:guideLst>
        <p:guide orient="horz" pos="1344"/>
        <p:guide pos="32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利彦 後藤" userId="7bb12374bb80fca2" providerId="LiveId" clId="{8388F411-DFA1-4940-B970-111CE5BC50D8}"/>
    <pc:docChg chg="undo custSel modSld">
      <pc:chgData name="利彦 後藤" userId="7bb12374bb80fca2" providerId="LiveId" clId="{8388F411-DFA1-4940-B970-111CE5BC50D8}" dt="2025-07-05T05:55:32.597" v="207" actId="27918"/>
      <pc:docMkLst>
        <pc:docMk/>
      </pc:docMkLst>
      <pc:sldChg chg="addSp delSp modSp mod">
        <pc:chgData name="利彦 後藤" userId="7bb12374bb80fca2" providerId="LiveId" clId="{8388F411-DFA1-4940-B970-111CE5BC50D8}" dt="2025-07-05T05:55:32.597" v="207" actId="27918"/>
        <pc:sldMkLst>
          <pc:docMk/>
          <pc:sldMk cId="843260897" sldId="299"/>
        </pc:sldMkLst>
        <pc:spChg chg="add mod">
          <ac:chgData name="利彦 後藤" userId="7bb12374bb80fca2" providerId="LiveId" clId="{8388F411-DFA1-4940-B970-111CE5BC50D8}" dt="2025-06-21T04:56:55.497" v="204" actId="554"/>
          <ac:spMkLst>
            <pc:docMk/>
            <pc:sldMk cId="843260897" sldId="299"/>
            <ac:spMk id="2" creationId="{DD123403-C84D-AE71-515C-0A700452229B}"/>
          </ac:spMkLst>
        </pc:spChg>
        <pc:spChg chg="add mod">
          <ac:chgData name="利彦 後藤" userId="7bb12374bb80fca2" providerId="LiveId" clId="{8388F411-DFA1-4940-B970-111CE5BC50D8}" dt="2025-06-21T04:56:55.497" v="204" actId="554"/>
          <ac:spMkLst>
            <pc:docMk/>
            <pc:sldMk cId="843260897" sldId="299"/>
            <ac:spMk id="3" creationId="{2A6CB1BF-83C1-4EBE-20D1-A41D81C26C93}"/>
          </ac:spMkLst>
        </pc:spChg>
        <pc:spChg chg="mod">
          <ac:chgData name="利彦 後藤" userId="7bb12374bb80fca2" providerId="LiveId" clId="{8388F411-DFA1-4940-B970-111CE5BC50D8}" dt="2025-06-21T03:45:26.461" v="158" actId="20577"/>
          <ac:spMkLst>
            <pc:docMk/>
            <pc:sldMk cId="843260897" sldId="299"/>
            <ac:spMk id="6" creationId="{4A43482F-97E5-653C-5CD0-925E66381B13}"/>
          </ac:spMkLst>
        </pc:spChg>
        <pc:spChg chg="add mod">
          <ac:chgData name="利彦 後藤" userId="7bb12374bb80fca2" providerId="LiveId" clId="{8388F411-DFA1-4940-B970-111CE5BC50D8}" dt="2025-06-19T11:58:26.949" v="156" actId="1036"/>
          <ac:spMkLst>
            <pc:docMk/>
            <pc:sldMk cId="843260897" sldId="299"/>
            <ac:spMk id="11" creationId="{F2F571F1-DFD8-59F6-D895-C602FB1C5968}"/>
          </ac:spMkLst>
        </pc:spChg>
        <pc:spChg chg="add mod">
          <ac:chgData name="利彦 後藤" userId="7bb12374bb80fca2" providerId="LiveId" clId="{8388F411-DFA1-4940-B970-111CE5BC50D8}" dt="2025-06-19T11:57:52.840" v="154" actId="554"/>
          <ac:spMkLst>
            <pc:docMk/>
            <pc:sldMk cId="843260897" sldId="299"/>
            <ac:spMk id="13" creationId="{2B417477-5251-D1DA-57CB-9470425A5079}"/>
          </ac:spMkLst>
        </pc:spChg>
        <pc:spChg chg="add mod">
          <ac:chgData name="利彦 後藤" userId="7bb12374bb80fca2" providerId="LiveId" clId="{8388F411-DFA1-4940-B970-111CE5BC50D8}" dt="2025-06-19T11:57:52.840" v="154" actId="554"/>
          <ac:spMkLst>
            <pc:docMk/>
            <pc:sldMk cId="843260897" sldId="299"/>
            <ac:spMk id="14" creationId="{D5259D9A-8A6D-A73D-D832-DE49E8F47F1D}"/>
          </ac:spMkLst>
        </pc:spChg>
        <pc:graphicFrameChg chg="add mod">
          <ac:chgData name="利彦 後藤" userId="7bb12374bb80fca2" providerId="LiveId" clId="{8388F411-DFA1-4940-B970-111CE5BC50D8}" dt="2025-06-19T11:50:34.975" v="62" actId="255"/>
          <ac:graphicFrameMkLst>
            <pc:docMk/>
            <pc:sldMk cId="843260897" sldId="299"/>
            <ac:graphicFrameMk id="5" creationId="{8BC601E7-9FC7-675E-95CD-726954ED6BA2}"/>
          </ac:graphicFrameMkLst>
        </pc:graphicFrameChg>
        <pc:cxnChg chg="add mod">
          <ac:chgData name="利彦 後藤" userId="7bb12374bb80fca2" providerId="LiveId" clId="{8388F411-DFA1-4940-B970-111CE5BC50D8}" dt="2025-06-19T11:58:26.949" v="156" actId="1036"/>
          <ac:cxnSpMkLst>
            <pc:docMk/>
            <pc:sldMk cId="843260897" sldId="299"/>
            <ac:cxnSpMk id="10" creationId="{9E49E235-84E8-48B9-7977-FBD4A47BA728}"/>
          </ac:cxnSpMkLst>
        </pc:cxnChg>
        <pc:cxnChg chg="add mod">
          <ac:chgData name="利彦 後藤" userId="7bb12374bb80fca2" providerId="LiveId" clId="{8388F411-DFA1-4940-B970-111CE5BC50D8}" dt="2025-06-19T11:58:02.240" v="155" actId="554"/>
          <ac:cxnSpMkLst>
            <pc:docMk/>
            <pc:sldMk cId="843260897" sldId="299"/>
            <ac:cxnSpMk id="16" creationId="{29CC0F83-54A6-37F2-B692-07B877805450}"/>
          </ac:cxnSpMkLst>
        </pc:cxnChg>
        <pc:cxnChg chg="add mod">
          <ac:chgData name="利彦 後藤" userId="7bb12374bb80fca2" providerId="LiveId" clId="{8388F411-DFA1-4940-B970-111CE5BC50D8}" dt="2025-06-19T11:58:02.240" v="155" actId="554"/>
          <ac:cxnSpMkLst>
            <pc:docMk/>
            <pc:sldMk cId="843260897" sldId="299"/>
            <ac:cxnSpMk id="17" creationId="{15B3E316-A0EB-30B9-5590-A31981F1E538}"/>
          </ac:cxnSpMkLst>
        </pc:cxnChg>
      </pc:sldChg>
    </pc:docChg>
  </pc:docChgLst>
  <pc:docChgLst>
    <pc:chgData name="利彦 後藤" userId="7bb12374bb80fca2" providerId="LiveId" clId="{833EC101-F68D-4027-9FB0-A03D6791E674}"/>
    <pc:docChg chg="undo custSel addSld delSld modSld">
      <pc:chgData name="利彦 後藤" userId="7bb12374bb80fca2" providerId="LiveId" clId="{833EC101-F68D-4027-9FB0-A03D6791E674}" dt="2025-04-03T11:48:08.876" v="89" actId="1076"/>
      <pc:docMkLst>
        <pc:docMk/>
      </pc:docMkLst>
      <pc:sldChg chg="del">
        <pc:chgData name="利彦 後藤" userId="7bb12374bb80fca2" providerId="LiveId" clId="{833EC101-F68D-4027-9FB0-A03D6791E674}" dt="2025-04-02T01:54:43.501" v="0" actId="2696"/>
        <pc:sldMkLst>
          <pc:docMk/>
          <pc:sldMk cId="554958816" sldId="292"/>
        </pc:sldMkLst>
      </pc:sldChg>
      <pc:sldChg chg="del">
        <pc:chgData name="利彦 後藤" userId="7bb12374bb80fca2" providerId="LiveId" clId="{833EC101-F68D-4027-9FB0-A03D6791E674}" dt="2025-04-02T01:54:54.609" v="1" actId="2696"/>
        <pc:sldMkLst>
          <pc:docMk/>
          <pc:sldMk cId="1011026366" sldId="293"/>
        </pc:sldMkLst>
      </pc:sldChg>
      <pc:sldChg chg="del">
        <pc:chgData name="利彦 後藤" userId="7bb12374bb80fca2" providerId="LiveId" clId="{833EC101-F68D-4027-9FB0-A03D6791E674}" dt="2025-04-02T01:54:58.101" v="2" actId="2696"/>
        <pc:sldMkLst>
          <pc:docMk/>
          <pc:sldMk cId="1510655572" sldId="294"/>
        </pc:sldMkLst>
      </pc:sldChg>
      <pc:sldChg chg="del">
        <pc:chgData name="利彦 後藤" userId="7bb12374bb80fca2" providerId="LiveId" clId="{833EC101-F68D-4027-9FB0-A03D6791E674}" dt="2025-04-02T01:55:02.611" v="3" actId="2696"/>
        <pc:sldMkLst>
          <pc:docMk/>
          <pc:sldMk cId="1011946836" sldId="295"/>
        </pc:sldMkLst>
      </pc:sldChg>
      <pc:sldChg chg="del">
        <pc:chgData name="利彦 後藤" userId="7bb12374bb80fca2" providerId="LiveId" clId="{833EC101-F68D-4027-9FB0-A03D6791E674}" dt="2025-04-02T02:22:28.017" v="23" actId="2696"/>
        <pc:sldMkLst>
          <pc:docMk/>
          <pc:sldMk cId="469806462" sldId="296"/>
        </pc:sldMkLst>
      </pc:sldChg>
      <pc:sldChg chg="del">
        <pc:chgData name="利彦 後藤" userId="7bb12374bb80fca2" providerId="LiveId" clId="{833EC101-F68D-4027-9FB0-A03D6791E674}" dt="2025-04-02T02:22:49.389" v="25" actId="2696"/>
        <pc:sldMkLst>
          <pc:docMk/>
          <pc:sldMk cId="1653692598" sldId="297"/>
        </pc:sldMkLst>
      </pc:sldChg>
      <pc:sldChg chg="del">
        <pc:chgData name="利彦 後藤" userId="7bb12374bb80fca2" providerId="LiveId" clId="{833EC101-F68D-4027-9FB0-A03D6791E674}" dt="2025-04-02T02:22:59.531" v="26" actId="2696"/>
        <pc:sldMkLst>
          <pc:docMk/>
          <pc:sldMk cId="1165956343" sldId="298"/>
        </pc:sldMkLst>
      </pc:sldChg>
      <pc:sldChg chg="addSp delSp modSp mod setBg">
        <pc:chgData name="利彦 後藤" userId="7bb12374bb80fca2" providerId="LiveId" clId="{833EC101-F68D-4027-9FB0-A03D6791E674}" dt="2025-04-03T11:48:08.876" v="89" actId="1076"/>
        <pc:sldMkLst>
          <pc:docMk/>
          <pc:sldMk cId="843260897" sldId="299"/>
        </pc:sldMkLst>
      </pc:sldChg>
      <pc:sldChg chg="del">
        <pc:chgData name="利彦 後藤" userId="7bb12374bb80fca2" providerId="LiveId" clId="{833EC101-F68D-4027-9FB0-A03D6791E674}" dt="2025-04-02T02:23:39.798" v="28" actId="2696"/>
        <pc:sldMkLst>
          <pc:docMk/>
          <pc:sldMk cId="2666742861" sldId="300"/>
        </pc:sldMkLst>
      </pc:sldChg>
      <pc:sldChg chg="del">
        <pc:chgData name="利彦 後藤" userId="7bb12374bb80fca2" providerId="LiveId" clId="{833EC101-F68D-4027-9FB0-A03D6791E674}" dt="2025-04-02T02:23:42.741" v="29" actId="2696"/>
        <pc:sldMkLst>
          <pc:docMk/>
          <pc:sldMk cId="617704008" sldId="301"/>
        </pc:sldMkLst>
      </pc:sldChg>
      <pc:sldChg chg="del">
        <pc:chgData name="利彦 後藤" userId="7bb12374bb80fca2" providerId="LiveId" clId="{833EC101-F68D-4027-9FB0-A03D6791E674}" dt="2025-04-02T02:23:45.953" v="30" actId="2696"/>
        <pc:sldMkLst>
          <pc:docMk/>
          <pc:sldMk cId="1939689004" sldId="302"/>
        </pc:sldMkLst>
      </pc:sldChg>
      <pc:sldChg chg="del">
        <pc:chgData name="利彦 後藤" userId="7bb12374bb80fca2" providerId="LiveId" clId="{833EC101-F68D-4027-9FB0-A03D6791E674}" dt="2025-04-02T02:23:48.815" v="31" actId="2696"/>
        <pc:sldMkLst>
          <pc:docMk/>
          <pc:sldMk cId="360673529" sldId="303"/>
        </pc:sldMkLst>
      </pc:sldChg>
      <pc:sldChg chg="del">
        <pc:chgData name="利彦 後藤" userId="7bb12374bb80fca2" providerId="LiveId" clId="{833EC101-F68D-4027-9FB0-A03D6791E674}" dt="2025-04-02T02:23:12.517" v="27" actId="2696"/>
        <pc:sldMkLst>
          <pc:docMk/>
          <pc:sldMk cId="4081029767" sldId="304"/>
        </pc:sldMkLst>
      </pc:sldChg>
      <pc:sldChg chg="del">
        <pc:chgData name="利彦 後藤" userId="7bb12374bb80fca2" providerId="LiveId" clId="{833EC101-F68D-4027-9FB0-A03D6791E674}" dt="2025-04-02T02:22:05.841" v="22" actId="2696"/>
        <pc:sldMkLst>
          <pc:docMk/>
          <pc:sldMk cId="492824263" sldId="305"/>
        </pc:sldMkLst>
      </pc:sldChg>
      <pc:sldChg chg="del">
        <pc:chgData name="利彦 後藤" userId="7bb12374bb80fca2" providerId="LiveId" clId="{833EC101-F68D-4027-9FB0-A03D6791E674}" dt="2025-04-02T02:22:00.878" v="21" actId="2696"/>
        <pc:sldMkLst>
          <pc:docMk/>
          <pc:sldMk cId="3174374776" sldId="306"/>
        </pc:sldMkLst>
      </pc:sldChg>
      <pc:sldChg chg="del">
        <pc:chgData name="利彦 後藤" userId="7bb12374bb80fca2" providerId="LiveId" clId="{833EC101-F68D-4027-9FB0-A03D6791E674}" dt="2025-04-02T02:21:55.548" v="20" actId="2696"/>
        <pc:sldMkLst>
          <pc:docMk/>
          <pc:sldMk cId="2193906979" sldId="307"/>
        </pc:sldMkLst>
      </pc:sldChg>
      <pc:sldChg chg="del">
        <pc:chgData name="利彦 後藤" userId="7bb12374bb80fca2" providerId="LiveId" clId="{833EC101-F68D-4027-9FB0-A03D6791E674}" dt="2025-04-02T02:21:52.797" v="19" actId="2696"/>
        <pc:sldMkLst>
          <pc:docMk/>
          <pc:sldMk cId="1673431442" sldId="308"/>
        </pc:sldMkLst>
      </pc:sldChg>
      <pc:sldChg chg="del">
        <pc:chgData name="利彦 後藤" userId="7bb12374bb80fca2" providerId="LiveId" clId="{833EC101-F68D-4027-9FB0-A03D6791E674}" dt="2025-04-02T02:21:49.871" v="18" actId="2696"/>
        <pc:sldMkLst>
          <pc:docMk/>
          <pc:sldMk cId="1665562569" sldId="309"/>
        </pc:sldMkLst>
      </pc:sldChg>
      <pc:sldChg chg="del">
        <pc:chgData name="利彦 後藤" userId="7bb12374bb80fca2" providerId="LiveId" clId="{833EC101-F68D-4027-9FB0-A03D6791E674}" dt="2025-04-02T02:21:46.743" v="17" actId="2696"/>
        <pc:sldMkLst>
          <pc:docMk/>
          <pc:sldMk cId="1253218691" sldId="310"/>
        </pc:sldMkLst>
      </pc:sldChg>
      <pc:sldChg chg="del">
        <pc:chgData name="利彦 後藤" userId="7bb12374bb80fca2" providerId="LiveId" clId="{833EC101-F68D-4027-9FB0-A03D6791E674}" dt="2025-04-02T02:21:43.744" v="16" actId="2696"/>
        <pc:sldMkLst>
          <pc:docMk/>
          <pc:sldMk cId="462989813" sldId="311"/>
        </pc:sldMkLst>
      </pc:sldChg>
      <pc:sldChg chg="del">
        <pc:chgData name="利彦 後藤" userId="7bb12374bb80fca2" providerId="LiveId" clId="{833EC101-F68D-4027-9FB0-A03D6791E674}" dt="2025-04-02T02:21:40.840" v="15" actId="2696"/>
        <pc:sldMkLst>
          <pc:docMk/>
          <pc:sldMk cId="2706581280" sldId="312"/>
        </pc:sldMkLst>
      </pc:sldChg>
      <pc:sldChg chg="del">
        <pc:chgData name="利彦 後藤" userId="7bb12374bb80fca2" providerId="LiveId" clId="{833EC101-F68D-4027-9FB0-A03D6791E674}" dt="2025-04-02T02:21:38.313" v="14" actId="2696"/>
        <pc:sldMkLst>
          <pc:docMk/>
          <pc:sldMk cId="2814428001" sldId="313"/>
        </pc:sldMkLst>
      </pc:sldChg>
      <pc:sldChg chg="del">
        <pc:chgData name="利彦 後藤" userId="7bb12374bb80fca2" providerId="LiveId" clId="{833EC101-F68D-4027-9FB0-A03D6791E674}" dt="2025-04-02T02:21:35.720" v="13" actId="2696"/>
        <pc:sldMkLst>
          <pc:docMk/>
          <pc:sldMk cId="3436809" sldId="314"/>
        </pc:sldMkLst>
      </pc:sldChg>
      <pc:sldChg chg="del">
        <pc:chgData name="利彦 後藤" userId="7bb12374bb80fca2" providerId="LiveId" clId="{833EC101-F68D-4027-9FB0-A03D6791E674}" dt="2025-04-02T02:21:18.377" v="11" actId="2696"/>
        <pc:sldMkLst>
          <pc:docMk/>
          <pc:sldMk cId="269284632" sldId="315"/>
        </pc:sldMkLst>
      </pc:sldChg>
      <pc:sldChg chg="del">
        <pc:chgData name="利彦 後藤" userId="7bb12374bb80fca2" providerId="LiveId" clId="{833EC101-F68D-4027-9FB0-A03D6791E674}" dt="2025-04-02T02:21:32.103" v="12" actId="2696"/>
        <pc:sldMkLst>
          <pc:docMk/>
          <pc:sldMk cId="4020557232" sldId="316"/>
        </pc:sldMkLst>
      </pc:sldChg>
      <pc:sldChg chg="del">
        <pc:chgData name="利彦 後藤" userId="7bb12374bb80fca2" providerId="LiveId" clId="{833EC101-F68D-4027-9FB0-A03D6791E674}" dt="2025-04-02T02:21:07.865" v="10" actId="2696"/>
        <pc:sldMkLst>
          <pc:docMk/>
          <pc:sldMk cId="236596293" sldId="317"/>
        </pc:sldMkLst>
      </pc:sldChg>
      <pc:sldChg chg="del">
        <pc:chgData name="利彦 後藤" userId="7bb12374bb80fca2" providerId="LiveId" clId="{833EC101-F68D-4027-9FB0-A03D6791E674}" dt="2025-04-02T02:21:07.865" v="10" actId="2696"/>
        <pc:sldMkLst>
          <pc:docMk/>
          <pc:sldMk cId="1319282196" sldId="318"/>
        </pc:sldMkLst>
      </pc:sldChg>
      <pc:sldChg chg="del">
        <pc:chgData name="利彦 後藤" userId="7bb12374bb80fca2" providerId="LiveId" clId="{833EC101-F68D-4027-9FB0-A03D6791E674}" dt="2025-04-02T02:21:07.865" v="10" actId="2696"/>
        <pc:sldMkLst>
          <pc:docMk/>
          <pc:sldMk cId="818854316" sldId="319"/>
        </pc:sldMkLst>
      </pc:sldChg>
      <pc:sldChg chg="del">
        <pc:chgData name="利彦 後藤" userId="7bb12374bb80fca2" providerId="LiveId" clId="{833EC101-F68D-4027-9FB0-A03D6791E674}" dt="2025-04-02T02:21:07.865" v="10" actId="2696"/>
        <pc:sldMkLst>
          <pc:docMk/>
          <pc:sldMk cId="3125799933" sldId="320"/>
        </pc:sldMkLst>
      </pc:sldChg>
      <pc:sldChg chg="del">
        <pc:chgData name="利彦 後藤" userId="7bb12374bb80fca2" providerId="LiveId" clId="{833EC101-F68D-4027-9FB0-A03D6791E674}" dt="2025-04-02T02:21:07.865" v="10" actId="2696"/>
        <pc:sldMkLst>
          <pc:docMk/>
          <pc:sldMk cId="2215040174" sldId="321"/>
        </pc:sldMkLst>
      </pc:sldChg>
      <pc:sldChg chg="del">
        <pc:chgData name="利彦 後藤" userId="7bb12374bb80fca2" providerId="LiveId" clId="{833EC101-F68D-4027-9FB0-A03D6791E674}" dt="2025-04-02T02:20:59.820" v="9" actId="2696"/>
        <pc:sldMkLst>
          <pc:docMk/>
          <pc:sldMk cId="3494144747" sldId="322"/>
        </pc:sldMkLst>
      </pc:sldChg>
      <pc:sldChg chg="del">
        <pc:chgData name="利彦 後藤" userId="7bb12374bb80fca2" providerId="LiveId" clId="{833EC101-F68D-4027-9FB0-A03D6791E674}" dt="2025-04-02T02:20:59.820" v="9" actId="2696"/>
        <pc:sldMkLst>
          <pc:docMk/>
          <pc:sldMk cId="1028315483" sldId="323"/>
        </pc:sldMkLst>
      </pc:sldChg>
      <pc:sldChg chg="del">
        <pc:chgData name="利彦 後藤" userId="7bb12374bb80fca2" providerId="LiveId" clId="{833EC101-F68D-4027-9FB0-A03D6791E674}" dt="2025-04-02T02:20:59.820" v="9" actId="2696"/>
        <pc:sldMkLst>
          <pc:docMk/>
          <pc:sldMk cId="3231006251" sldId="324"/>
        </pc:sldMkLst>
      </pc:sldChg>
      <pc:sldChg chg="del">
        <pc:chgData name="利彦 後藤" userId="7bb12374bb80fca2" providerId="LiveId" clId="{833EC101-F68D-4027-9FB0-A03D6791E674}" dt="2025-04-02T02:20:59.820" v="9" actId="2696"/>
        <pc:sldMkLst>
          <pc:docMk/>
          <pc:sldMk cId="825975349" sldId="325"/>
        </pc:sldMkLst>
      </pc:sldChg>
      <pc:sldChg chg="del">
        <pc:chgData name="利彦 後藤" userId="7bb12374bb80fca2" providerId="LiveId" clId="{833EC101-F68D-4027-9FB0-A03D6791E674}" dt="2025-04-02T02:20:52.753" v="8" actId="2696"/>
        <pc:sldMkLst>
          <pc:docMk/>
          <pc:sldMk cId="3609757869" sldId="326"/>
        </pc:sldMkLst>
      </pc:sldChg>
      <pc:sldChg chg="del">
        <pc:chgData name="利彦 後藤" userId="7bb12374bb80fca2" providerId="LiveId" clId="{833EC101-F68D-4027-9FB0-A03D6791E674}" dt="2025-04-02T02:20:52.753" v="8" actId="2696"/>
        <pc:sldMkLst>
          <pc:docMk/>
          <pc:sldMk cId="3603263896" sldId="327"/>
        </pc:sldMkLst>
      </pc:sldChg>
      <pc:sldChg chg="del">
        <pc:chgData name="利彦 後藤" userId="7bb12374bb80fca2" providerId="LiveId" clId="{833EC101-F68D-4027-9FB0-A03D6791E674}" dt="2025-04-02T02:20:52.753" v="8" actId="2696"/>
        <pc:sldMkLst>
          <pc:docMk/>
          <pc:sldMk cId="3507945602" sldId="328"/>
        </pc:sldMkLst>
      </pc:sldChg>
      <pc:sldChg chg="del">
        <pc:chgData name="利彦 後藤" userId="7bb12374bb80fca2" providerId="LiveId" clId="{833EC101-F68D-4027-9FB0-A03D6791E674}" dt="2025-04-02T02:20:44.052" v="7" actId="2696"/>
        <pc:sldMkLst>
          <pc:docMk/>
          <pc:sldMk cId="3992950614" sldId="329"/>
        </pc:sldMkLst>
      </pc:sldChg>
      <pc:sldChg chg="del">
        <pc:chgData name="利彦 後藤" userId="7bb12374bb80fca2" providerId="LiveId" clId="{833EC101-F68D-4027-9FB0-A03D6791E674}" dt="2025-04-02T02:20:44.052" v="7" actId="2696"/>
        <pc:sldMkLst>
          <pc:docMk/>
          <pc:sldMk cId="2277439508" sldId="330"/>
        </pc:sldMkLst>
      </pc:sldChg>
      <pc:sldChg chg="del">
        <pc:chgData name="利彦 後藤" userId="7bb12374bb80fca2" providerId="LiveId" clId="{833EC101-F68D-4027-9FB0-A03D6791E674}" dt="2025-04-02T02:20:44.052" v="7" actId="2696"/>
        <pc:sldMkLst>
          <pc:docMk/>
          <pc:sldMk cId="3182587852" sldId="331"/>
        </pc:sldMkLst>
      </pc:sldChg>
      <pc:sldChg chg="del">
        <pc:chgData name="利彦 後藤" userId="7bb12374bb80fca2" providerId="LiveId" clId="{833EC101-F68D-4027-9FB0-A03D6791E674}" dt="2025-04-02T02:20:52.753" v="8" actId="2696"/>
        <pc:sldMkLst>
          <pc:docMk/>
          <pc:sldMk cId="2497330143" sldId="332"/>
        </pc:sldMkLst>
      </pc:sldChg>
      <pc:sldChg chg="del">
        <pc:chgData name="利彦 後藤" userId="7bb12374bb80fca2" providerId="LiveId" clId="{833EC101-F68D-4027-9FB0-A03D6791E674}" dt="2025-04-02T02:20:52.753" v="8" actId="2696"/>
        <pc:sldMkLst>
          <pc:docMk/>
          <pc:sldMk cId="3571179256" sldId="333"/>
        </pc:sldMkLst>
      </pc:sldChg>
      <pc:sldChg chg="del">
        <pc:chgData name="利彦 後藤" userId="7bb12374bb80fca2" providerId="LiveId" clId="{833EC101-F68D-4027-9FB0-A03D6791E674}" dt="2025-04-02T01:55:17.578" v="5" actId="2696"/>
        <pc:sldMkLst>
          <pc:docMk/>
          <pc:sldMk cId="639478118" sldId="334"/>
        </pc:sldMkLst>
      </pc:sldChg>
      <pc:sldChg chg="add del">
        <pc:chgData name="利彦 後藤" userId="7bb12374bb80fca2" providerId="LiveId" clId="{833EC101-F68D-4027-9FB0-A03D6791E674}" dt="2025-04-02T02:22:45.826" v="24" actId="2696"/>
        <pc:sldMkLst>
          <pc:docMk/>
          <pc:sldMk cId="3807140678" sldId="334"/>
        </pc:sldMkLst>
      </pc:sldChg>
      <pc:sldChg chg="del">
        <pc:chgData name="利彦 後藤" userId="7bb12374bb80fca2" providerId="LiveId" clId="{833EC101-F68D-4027-9FB0-A03D6791E674}" dt="2025-04-02T01:55:11.035" v="4" actId="2696"/>
        <pc:sldMkLst>
          <pc:docMk/>
          <pc:sldMk cId="3231834468" sldId="335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TGoto\Desktop\IH\&#12452;&#12488;&#12454;&#12498;&#12525;&#12471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A$17</c:f>
              <c:strCache>
                <c:ptCount val="1"/>
                <c:pt idx="0">
                  <c:v>Impedanc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Sheet1!$B$16:$K$16</c:f>
              <c:strCache>
                <c:ptCount val="10"/>
                <c:pt idx="0">
                  <c:v>Nov 13, 2024</c:v>
                </c:pt>
                <c:pt idx="1">
                  <c:v>Nov 18, 2024</c:v>
                </c:pt>
                <c:pt idx="2">
                  <c:v>Nov 27, 2024</c:v>
                </c:pt>
                <c:pt idx="3">
                  <c:v>Dec 2, 2024</c:v>
                </c:pt>
                <c:pt idx="4">
                  <c:v>Dec 5, 2024</c:v>
                </c:pt>
                <c:pt idx="5">
                  <c:v>Dec 27, 2024</c:v>
                </c:pt>
                <c:pt idx="6">
                  <c:v>Jan 3, 2025</c:v>
                </c:pt>
                <c:pt idx="7">
                  <c:v>Mar 11, 2025</c:v>
                </c:pt>
                <c:pt idx="8">
                  <c:v>Apr 8, 2025</c:v>
                </c:pt>
                <c:pt idx="9">
                  <c:v>June 23, 2025</c:v>
                </c:pt>
              </c:strCache>
            </c:strRef>
          </c:cat>
          <c:val>
            <c:numRef>
              <c:f>Sheet1!$B$17:$K$17</c:f>
              <c:numCache>
                <c:formatCode>General</c:formatCode>
                <c:ptCount val="10"/>
                <c:pt idx="0">
                  <c:v>790</c:v>
                </c:pt>
                <c:pt idx="1">
                  <c:v>390</c:v>
                </c:pt>
                <c:pt idx="2">
                  <c:v>350</c:v>
                </c:pt>
                <c:pt idx="3">
                  <c:v>370</c:v>
                </c:pt>
                <c:pt idx="4">
                  <c:v>380</c:v>
                </c:pt>
                <c:pt idx="5">
                  <c:v>660</c:v>
                </c:pt>
                <c:pt idx="6">
                  <c:v>640</c:v>
                </c:pt>
                <c:pt idx="7">
                  <c:v>660</c:v>
                </c:pt>
                <c:pt idx="8">
                  <c:v>580</c:v>
                </c:pt>
                <c:pt idx="9">
                  <c:v>59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497-4915-919F-F482C43C21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27519632"/>
        <c:axId val="1427522512"/>
      </c:lineChart>
      <c:lineChart>
        <c:grouping val="standard"/>
        <c:varyColors val="0"/>
        <c:ser>
          <c:idx val="1"/>
          <c:order val="1"/>
          <c:tx>
            <c:strRef>
              <c:f>Sheet1!$A$18</c:f>
              <c:strCache>
                <c:ptCount val="1"/>
                <c:pt idx="0">
                  <c:v>Threshold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Sheet1!$B$16:$K$16</c:f>
              <c:strCache>
                <c:ptCount val="10"/>
                <c:pt idx="0">
                  <c:v>Nov 13, 2024</c:v>
                </c:pt>
                <c:pt idx="1">
                  <c:v>Nov 18, 2024</c:v>
                </c:pt>
                <c:pt idx="2">
                  <c:v>Nov 27, 2024</c:v>
                </c:pt>
                <c:pt idx="3">
                  <c:v>Dec 2, 2024</c:v>
                </c:pt>
                <c:pt idx="4">
                  <c:v>Dec 5, 2024</c:v>
                </c:pt>
                <c:pt idx="5">
                  <c:v>Dec 27, 2024</c:v>
                </c:pt>
                <c:pt idx="6">
                  <c:v>Jan 3, 2025</c:v>
                </c:pt>
                <c:pt idx="7">
                  <c:v>Mar 11, 2025</c:v>
                </c:pt>
                <c:pt idx="8">
                  <c:v>Apr 8, 2025</c:v>
                </c:pt>
                <c:pt idx="9">
                  <c:v>June 23, 2025</c:v>
                </c:pt>
              </c:strCache>
            </c:strRef>
          </c:cat>
          <c:val>
            <c:numRef>
              <c:f>Sheet1!$B$18:$K$18</c:f>
              <c:numCache>
                <c:formatCode>General</c:formatCode>
                <c:ptCount val="10"/>
                <c:pt idx="0">
                  <c:v>1</c:v>
                </c:pt>
                <c:pt idx="1">
                  <c:v>0.75</c:v>
                </c:pt>
                <c:pt idx="2">
                  <c:v>4</c:v>
                </c:pt>
                <c:pt idx="3">
                  <c:v>6</c:v>
                </c:pt>
                <c:pt idx="4">
                  <c:v>6</c:v>
                </c:pt>
                <c:pt idx="5">
                  <c:v>0.5</c:v>
                </c:pt>
                <c:pt idx="6">
                  <c:v>0.5</c:v>
                </c:pt>
                <c:pt idx="7">
                  <c:v>0.5</c:v>
                </c:pt>
                <c:pt idx="8">
                  <c:v>0.5</c:v>
                </c:pt>
                <c:pt idx="9">
                  <c:v>0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497-4915-919F-F482C43C21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73867904"/>
        <c:axId val="1373861664"/>
      </c:lineChart>
      <c:catAx>
        <c:axId val="1427519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427522512"/>
        <c:crosses val="autoZero"/>
        <c:auto val="1"/>
        <c:lblAlgn val="ctr"/>
        <c:lblOffset val="100"/>
        <c:noMultiLvlLbl val="0"/>
      </c:catAx>
      <c:valAx>
        <c:axId val="14275225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427519632"/>
        <c:crosses val="autoZero"/>
        <c:crossBetween val="between"/>
      </c:valAx>
      <c:valAx>
        <c:axId val="1373861664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373867904"/>
        <c:crosses val="max"/>
        <c:crossBetween val="between"/>
      </c:valAx>
      <c:catAx>
        <c:axId val="13738679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37386166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6"/>
            <a:ext cx="874395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A6ED-757D-4F69-8153-DC2BB2E71DF7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DA883-84F4-4B4C-B28F-6EEEC02CF5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9287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A6ED-757D-4F69-8153-DC2BB2E71DF7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DA883-84F4-4B4C-B28F-6EEEC02CF5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170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390335" y="274639"/>
            <a:ext cx="2603897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78644" y="274639"/>
            <a:ext cx="7640241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A6ED-757D-4F69-8153-DC2BB2E71DF7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DA883-84F4-4B4C-B28F-6EEEC02CF5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5064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A6ED-757D-4F69-8153-DC2BB2E71DF7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DA883-84F4-4B4C-B28F-6EEEC02CF5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8086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602" y="4406901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602" y="2906713"/>
            <a:ext cx="874395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A6ED-757D-4F69-8153-DC2BB2E71DF7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DA883-84F4-4B4C-B28F-6EEEC02CF5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1207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78644" y="1600201"/>
            <a:ext cx="512206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872162" y="1600201"/>
            <a:ext cx="512206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A6ED-757D-4F69-8153-DC2BB2E71DF7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DA883-84F4-4B4C-B28F-6EEEC02CF5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9112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21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21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5654" y="1535113"/>
            <a:ext cx="454699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5654" y="2174875"/>
            <a:ext cx="454699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A6ED-757D-4F69-8153-DC2BB2E71DF7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DA883-84F4-4B4C-B28F-6EEEC02CF5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5287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A6ED-757D-4F69-8153-DC2BB2E71DF7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DA883-84F4-4B4C-B28F-6EEEC02CF5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9051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A6ED-757D-4F69-8153-DC2BB2E71DF7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DA883-84F4-4B4C-B28F-6EEEC02CF5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5911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1" y="273050"/>
            <a:ext cx="338435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1931" y="273051"/>
            <a:ext cx="575071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1" y="1435101"/>
            <a:ext cx="338435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A6ED-757D-4F69-8153-DC2BB2E71DF7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DA883-84F4-4B4C-B28F-6EEEC02CF5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8896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324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324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324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1A6ED-757D-4F69-8153-DC2BB2E71DF7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DA883-84F4-4B4C-B28F-6EEEC02CF5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4471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00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600201"/>
            <a:ext cx="92583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14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1A6ED-757D-4F69-8153-DC2BB2E71DF7}" type="datetimeFigureOut">
              <a:rPr kumimoji="1" lang="ja-JP" altLang="en-US" smtClean="0"/>
              <a:t>2025/7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514725" y="6356351"/>
            <a:ext cx="32575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372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CDA883-84F4-4B4C-B28F-6EEEC02CF5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26040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A43482F-97E5-653C-5CD0-925E66381B13}"/>
              </a:ext>
            </a:extLst>
          </p:cNvPr>
          <p:cNvSpPr txBox="1"/>
          <p:nvPr/>
        </p:nvSpPr>
        <p:spPr>
          <a:xfrm>
            <a:off x="174948" y="116632"/>
            <a:ext cx="25922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pplementary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0B2B818-AA95-DB15-45C3-9D72E8A3B877}"/>
              </a:ext>
            </a:extLst>
          </p:cNvPr>
          <p:cNvSpPr txBox="1"/>
          <p:nvPr/>
        </p:nvSpPr>
        <p:spPr>
          <a:xfrm>
            <a:off x="2119164" y="836712"/>
            <a:ext cx="4320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kern="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R</a:t>
            </a:r>
            <a:endParaRPr lang="en-US" altLang="ja-JP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8BC601E7-9FC7-675E-95CD-726954ED6B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42541812"/>
              </p:ext>
            </p:extLst>
          </p:nvPr>
        </p:nvGraphicFramePr>
        <p:xfrm>
          <a:off x="1687116" y="1412776"/>
          <a:ext cx="7200800" cy="4320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9E49E235-84E8-48B9-7977-FBD4A47BA728}"/>
              </a:ext>
            </a:extLst>
          </p:cNvPr>
          <p:cNvCxnSpPr>
            <a:cxnSpLocks/>
          </p:cNvCxnSpPr>
          <p:nvPr/>
        </p:nvCxnSpPr>
        <p:spPr>
          <a:xfrm>
            <a:off x="5647556" y="2060848"/>
            <a:ext cx="936104" cy="0"/>
          </a:xfrm>
          <a:prstGeom prst="line">
            <a:avLst/>
          </a:prstGeom>
          <a:ln w="2222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2F571F1-DFD8-59F6-D895-C602FB1C5968}"/>
              </a:ext>
            </a:extLst>
          </p:cNvPr>
          <p:cNvSpPr txBox="1"/>
          <p:nvPr/>
        </p:nvSpPr>
        <p:spPr>
          <a:xfrm>
            <a:off x="6583660" y="1876182"/>
            <a:ext cx="4395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B417477-5251-D1DA-57CB-9470425A5079}"/>
              </a:ext>
            </a:extLst>
          </p:cNvPr>
          <p:cNvSpPr txBox="1"/>
          <p:nvPr/>
        </p:nvSpPr>
        <p:spPr>
          <a:xfrm rot="16200000">
            <a:off x="1686464" y="116117"/>
            <a:ext cx="461665" cy="1900520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mpedance (ohm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5259D9A-8A6D-A73D-D832-DE49E8F47F1D}"/>
              </a:ext>
            </a:extLst>
          </p:cNvPr>
          <p:cNvSpPr txBox="1"/>
          <p:nvPr/>
        </p:nvSpPr>
        <p:spPr>
          <a:xfrm rot="16200000">
            <a:off x="8466056" y="321301"/>
            <a:ext cx="461665" cy="149015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hreshold (V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29CC0F83-54A6-37F2-B692-07B877805450}"/>
              </a:ext>
            </a:extLst>
          </p:cNvPr>
          <p:cNvCxnSpPr>
            <a:cxnSpLocks/>
          </p:cNvCxnSpPr>
          <p:nvPr/>
        </p:nvCxnSpPr>
        <p:spPr>
          <a:xfrm>
            <a:off x="462980" y="1066377"/>
            <a:ext cx="432048" cy="0"/>
          </a:xfrm>
          <a:prstGeom prst="line">
            <a:avLst/>
          </a:prstGeom>
          <a:ln w="22225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15B3E316-A0EB-30B9-5590-A31981F1E538}"/>
              </a:ext>
            </a:extLst>
          </p:cNvPr>
          <p:cNvCxnSpPr>
            <a:cxnSpLocks/>
          </p:cNvCxnSpPr>
          <p:nvPr/>
        </p:nvCxnSpPr>
        <p:spPr>
          <a:xfrm>
            <a:off x="7375748" y="1066377"/>
            <a:ext cx="432048" cy="0"/>
          </a:xfrm>
          <a:prstGeom prst="line">
            <a:avLst/>
          </a:prstGeom>
          <a:ln w="222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D123403-C84D-AE71-515C-0A700452229B}"/>
              </a:ext>
            </a:extLst>
          </p:cNvPr>
          <p:cNvSpPr txBox="1"/>
          <p:nvPr/>
        </p:nvSpPr>
        <p:spPr>
          <a:xfrm>
            <a:off x="1975148" y="5716764"/>
            <a:ext cx="136815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rst implantation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A6CB1BF-83C1-4EBE-20D1-A41D81C26C93}"/>
              </a:ext>
            </a:extLst>
          </p:cNvPr>
          <p:cNvSpPr txBox="1"/>
          <p:nvPr/>
        </p:nvSpPr>
        <p:spPr>
          <a:xfrm>
            <a:off x="4999484" y="5716764"/>
            <a:ext cx="136815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econd implantation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32608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 2007 - 2010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 2007 - 2010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2007 - 2010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69</TotalTime>
  <Words>18</Words>
  <Application>Microsoft Office PowerPoint</Application>
  <PresentationFormat>35mm スライド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dministrator</dc:creator>
  <cp:lastModifiedBy>利彦 後藤</cp:lastModifiedBy>
  <cp:revision>6</cp:revision>
  <dcterms:created xsi:type="dcterms:W3CDTF">2025-03-31T00:05:29Z</dcterms:created>
  <dcterms:modified xsi:type="dcterms:W3CDTF">2025-07-05T05:55:41Z</dcterms:modified>
</cp:coreProperties>
</file>